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5867400"/>
            <a:ext cx="8419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</a:t>
            </a:r>
            <a:r>
              <a:rPr lang="en-US" sz="1200" b="1" dirty="0" smtClean="0">
                <a:latin typeface="Times New Roman"/>
                <a:ea typeface="Times New Roman"/>
              </a:rPr>
              <a:t>10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groups in one of the six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 wit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least t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genes between any two of the fou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ccessive sub-apical internodes (Int1-Int4) of bioenergy sorghum inbr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.07020.</a:t>
            </a:r>
            <a:endParaRPr lang="en-US" sz="12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757779" y="5410200"/>
            <a:ext cx="15688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genes</a:t>
            </a:r>
            <a:endParaRPr 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7200" y="228600"/>
            <a:ext cx="8419001" cy="52461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3854792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4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5:57Z</dcterms:modified>
</cp:coreProperties>
</file>